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F83ED-2DC0-4856-96E2-3417C08744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1C9C8-EDA2-4212-856F-6A78525886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94012-AB5F-48F1-8261-503B32E561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C7DEA-3E81-4C20-BC57-FBFACA85F6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03822-5EE2-4B2B-BE81-7F98747DAC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6A925-7C56-4A2A-96B1-A78B153BCB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CEEA6-EEDD-4336-8B72-71B4201AFA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FA477-546D-4B09-989B-1241F8C968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CD489-3113-4E8C-92D8-4875C77741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76F53-9DFD-4B26-A9A1-3E65C7CDE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69D92-78EC-4550-AA24-450C2D5B4A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CE85D-CAFE-4602-9771-207C4BF6C7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F36931-0984-465B-A403-695F567238A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9"/>
          <p:cNvGrpSpPr/>
          <p:nvPr/>
        </p:nvGrpSpPr>
        <p:grpSpPr>
          <a:xfrm>
            <a:off x="58680" y="1658880"/>
            <a:ext cx="5122800" cy="3144240"/>
            <a:chOff x="58680" y="1658880"/>
            <a:chExt cx="5122800" cy="3144240"/>
          </a:xfrm>
        </p:grpSpPr>
        <p:sp>
          <p:nvSpPr>
            <p:cNvPr id="42" name="TextBox 7"/>
            <p:cNvSpPr/>
            <p:nvPr/>
          </p:nvSpPr>
          <p:spPr>
            <a:xfrm>
              <a:off x="2078280" y="4526640"/>
              <a:ext cx="54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Day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20"/>
            <p:cNvSpPr/>
            <p:nvPr/>
          </p:nvSpPr>
          <p:spPr>
            <a:xfrm>
              <a:off x="642240" y="4336200"/>
              <a:ext cx="312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             9          12         15          20       2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6"/>
            <p:cNvSpPr/>
            <p:nvPr/>
          </p:nvSpPr>
          <p:spPr>
            <a:xfrm rot="16200000">
              <a:off x="-650520" y="2790000"/>
              <a:ext cx="1695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umor volume (mm</a:t>
              </a:r>
              <a:r>
                <a:rPr b="1" lang="en-US" sz="1200" spc="-1" strike="noStrike" baseline="30000">
                  <a:solidFill>
                    <a:srgbClr val="000000"/>
                  </a:solidFill>
                  <a:latin typeface="Arial"/>
                  <a:ea typeface="宋体"/>
                </a:rPr>
                <a:t>3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图表 23" descr=""/>
            <p:cNvPicPr/>
            <p:nvPr/>
          </p:nvPicPr>
          <p:blipFill>
            <a:blip r:embed="rId1"/>
            <a:stretch/>
          </p:blipFill>
          <p:spPr>
            <a:xfrm>
              <a:off x="316440" y="1658880"/>
              <a:ext cx="4865040" cy="2755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12"/>
            <p:cNvSpPr/>
            <p:nvPr/>
          </p:nvSpPr>
          <p:spPr>
            <a:xfrm>
              <a:off x="2125080" y="2610360"/>
              <a:ext cx="622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GPIb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直接箭头连接符 25"/>
            <p:cNvCxnSpPr/>
            <p:nvPr/>
          </p:nvCxnSpPr>
          <p:spPr>
            <a:xfrm>
              <a:off x="2428920" y="2959920"/>
              <a:ext cx="1080" cy="43128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48" name="TextBox 38"/>
          <p:cNvSpPr/>
          <p:nvPr/>
        </p:nvSpPr>
        <p:spPr>
          <a:xfrm>
            <a:off x="2520" y="139860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0"/>
          <p:cNvSpPr/>
          <p:nvPr/>
        </p:nvSpPr>
        <p:spPr>
          <a:xfrm>
            <a:off x="4336560" y="730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组合 46"/>
          <p:cNvGrpSpPr/>
          <p:nvPr/>
        </p:nvGrpSpPr>
        <p:grpSpPr>
          <a:xfrm>
            <a:off x="5367240" y="0"/>
            <a:ext cx="3103560" cy="3551400"/>
            <a:chOff x="5367240" y="0"/>
            <a:chExt cx="3103560" cy="3551400"/>
          </a:xfrm>
        </p:grpSpPr>
        <p:pic>
          <p:nvPicPr>
            <p:cNvPr id="51" name="Picture 3" descr="C:\Users\Jianbo\Desktop\Final\2013-1-18ren\2013-1-18ren-2\14F-40-1.jpg"/>
            <p:cNvPicPr/>
            <p:nvPr/>
          </p:nvPicPr>
          <p:blipFill>
            <a:blip r:embed="rId2">
              <a:lum contrast="20000"/>
            </a:blip>
            <a:stretch/>
          </p:blipFill>
          <p:spPr>
            <a:xfrm>
              <a:off x="5367240" y="274320"/>
              <a:ext cx="1536480" cy="203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4" descr="C:\Users\Jianbo\Desktop\Final\2013-1-18ren\2013-1-18ren-2\2F-40-2.jpg"/>
            <p:cNvPicPr/>
            <p:nvPr/>
          </p:nvPicPr>
          <p:blipFill>
            <a:blip r:embed="rId3">
              <a:lum contrast="20000"/>
            </a:blip>
            <a:stretch/>
          </p:blipFill>
          <p:spPr>
            <a:xfrm>
              <a:off x="6934320" y="274320"/>
              <a:ext cx="1536480" cy="2032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5" descr="C:\Users\Jianbo\Desktop\Final\2013-1-18ren\2F-2-4002.jpg"/>
            <p:cNvPicPr/>
            <p:nvPr/>
          </p:nvPicPr>
          <p:blipFill>
            <a:blip r:embed="rId4"/>
            <a:srcRect l="0" t="17500" r="0" b="22498"/>
            <a:stretch/>
          </p:blipFill>
          <p:spPr>
            <a:xfrm>
              <a:off x="6934320" y="2332080"/>
              <a:ext cx="1536480" cy="1219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6" descr="C:\Users\Jianbo\Desktop\Final\2013-1-18ren\14F-2-4002.jpg"/>
            <p:cNvPicPr/>
            <p:nvPr/>
          </p:nvPicPr>
          <p:blipFill>
            <a:blip r:embed="rId5"/>
            <a:srcRect l="0" t="0" r="0" b="41250"/>
            <a:stretch/>
          </p:blipFill>
          <p:spPr>
            <a:xfrm>
              <a:off x="5367240" y="2357640"/>
              <a:ext cx="1536480" cy="119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 Box 69"/>
            <p:cNvSpPr/>
            <p:nvPr/>
          </p:nvSpPr>
          <p:spPr>
            <a:xfrm>
              <a:off x="5729400" y="0"/>
              <a:ext cx="72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70"/>
            <p:cNvSpPr/>
            <p:nvPr/>
          </p:nvSpPr>
          <p:spPr>
            <a:xfrm>
              <a:off x="7133400" y="0"/>
              <a:ext cx="1189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LT deple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7" name="直接箭头连接符 42"/>
            <p:cNvCxnSpPr/>
            <p:nvPr/>
          </p:nvCxnSpPr>
          <p:spPr>
            <a:xfrm flipV="1">
              <a:off x="5622480" y="1066320"/>
              <a:ext cx="153000" cy="3052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8" name="直接箭头连接符 43"/>
            <p:cNvCxnSpPr/>
            <p:nvPr/>
          </p:nvCxnSpPr>
          <p:spPr>
            <a:xfrm flipV="1">
              <a:off x="6231960" y="1523520"/>
              <a:ext cx="153000" cy="30528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9" name="直接箭头连接符 44"/>
            <p:cNvCxnSpPr/>
            <p:nvPr/>
          </p:nvCxnSpPr>
          <p:spPr>
            <a:xfrm flipH="1" flipV="1">
              <a:off x="7603560" y="1142280"/>
              <a:ext cx="76680" cy="229320"/>
            </a:xfrm>
            <a:prstGeom prst="straightConnector1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0" name="直接连接符 61"/>
            <p:cNvSpPr/>
            <p:nvPr/>
          </p:nvSpPr>
          <p:spPr>
            <a:xfrm>
              <a:off x="8061480" y="213372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直接连接符 62"/>
            <p:cNvSpPr/>
            <p:nvPr/>
          </p:nvSpPr>
          <p:spPr>
            <a:xfrm>
              <a:off x="6537240" y="2133720"/>
              <a:ext cx="3045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接连接符 63"/>
            <p:cNvSpPr/>
            <p:nvPr/>
          </p:nvSpPr>
          <p:spPr>
            <a:xfrm>
              <a:off x="6626160" y="3429360"/>
              <a:ext cx="207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接连接符 64"/>
            <p:cNvSpPr/>
            <p:nvPr/>
          </p:nvSpPr>
          <p:spPr>
            <a:xfrm>
              <a:off x="8158320" y="3429360"/>
              <a:ext cx="207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组合 50"/>
          <p:cNvGrpSpPr/>
          <p:nvPr/>
        </p:nvGrpSpPr>
        <p:grpSpPr>
          <a:xfrm>
            <a:off x="5257800" y="3886200"/>
            <a:ext cx="3200400" cy="2440440"/>
            <a:chOff x="5257800" y="3886200"/>
            <a:chExt cx="3200400" cy="2440440"/>
          </a:xfrm>
        </p:grpSpPr>
        <p:sp>
          <p:nvSpPr>
            <p:cNvPr id="65" name="Text Box 57"/>
            <p:cNvSpPr/>
            <p:nvPr/>
          </p:nvSpPr>
          <p:spPr>
            <a:xfrm rot="16200000">
              <a:off x="4436280" y="4997880"/>
              <a:ext cx="191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etastatic lung nodul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58"/>
            <p:cNvSpPr/>
            <p:nvPr/>
          </p:nvSpPr>
          <p:spPr>
            <a:xfrm>
              <a:off x="6122520" y="6050160"/>
              <a:ext cx="72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59"/>
            <p:cNvSpPr/>
            <p:nvPr/>
          </p:nvSpPr>
          <p:spPr>
            <a:xfrm>
              <a:off x="7110720" y="6050160"/>
              <a:ext cx="1189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宋体"/>
                </a:rPr>
                <a:t>PLT deple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8" name="图表 47" descr=""/>
            <p:cNvPicPr/>
            <p:nvPr/>
          </p:nvPicPr>
          <p:blipFill>
            <a:blip r:embed="rId6"/>
            <a:stretch/>
          </p:blipFill>
          <p:spPr>
            <a:xfrm>
              <a:off x="5479920" y="3886200"/>
              <a:ext cx="2978280" cy="228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36"/>
            <p:cNvSpPr/>
            <p:nvPr/>
          </p:nvSpPr>
          <p:spPr>
            <a:xfrm>
              <a:off x="7562160" y="4802400"/>
              <a:ext cx="25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2T07:46:31Z</dcterms:created>
  <dc:creator>User</dc:creator>
  <dc:description/>
  <dc:language>en-US</dc:language>
  <cp:lastModifiedBy>User</cp:lastModifiedBy>
  <dcterms:modified xsi:type="dcterms:W3CDTF">2013-10-06T03:15:58Z</dcterms:modified>
  <cp:revision>14</cp:revision>
  <dc:subject/>
  <dc:title>幻灯片 1</dc:title>
</cp:coreProperties>
</file>